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C32A7D7-E9F0-7348-AA9A-6C8E5EE5DFAA}" v="1" dt="2022-10-21T03:22:06.74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 showGuides="1">
      <p:cViewPr varScale="1">
        <p:scale>
          <a:sx n="121" d="100"/>
          <a:sy n="121" d="100"/>
        </p:scale>
        <p:origin x="744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halingam, Mali - ARS" userId="5aabe30f-cbd6-478b-bfc6-4d9b76c11872" providerId="ADAL" clId="{5C32A7D7-E9F0-7348-AA9A-6C8E5EE5DFAA}"/>
    <pc:docChg chg="modSld">
      <pc:chgData name="Mahalingam, Mali - ARS" userId="5aabe30f-cbd6-478b-bfc6-4d9b76c11872" providerId="ADAL" clId="{5C32A7D7-E9F0-7348-AA9A-6C8E5EE5DFAA}" dt="2022-10-21T03:23:06.364" v="15" actId="1076"/>
      <pc:docMkLst>
        <pc:docMk/>
      </pc:docMkLst>
      <pc:sldChg chg="addSp modSp mod">
        <pc:chgData name="Mahalingam, Mali - ARS" userId="5aabe30f-cbd6-478b-bfc6-4d9b76c11872" providerId="ADAL" clId="{5C32A7D7-E9F0-7348-AA9A-6C8E5EE5DFAA}" dt="2022-10-21T03:23:06.364" v="15" actId="1076"/>
        <pc:sldMkLst>
          <pc:docMk/>
          <pc:sldMk cId="2245314376" sldId="256"/>
        </pc:sldMkLst>
        <pc:spChg chg="add mod">
          <ac:chgData name="Mahalingam, Mali - ARS" userId="5aabe30f-cbd6-478b-bfc6-4d9b76c11872" providerId="ADAL" clId="{5C32A7D7-E9F0-7348-AA9A-6C8E5EE5DFAA}" dt="2022-10-21T03:23:06.364" v="15" actId="1076"/>
          <ac:spMkLst>
            <pc:docMk/>
            <pc:sldMk cId="2245314376" sldId="256"/>
            <ac:spMk id="2" creationId="{38253975-3FC5-5A4D-9073-4006BFB16C1D}"/>
          </ac:spMkLst>
        </pc:spChg>
        <pc:picChg chg="mod modCrop">
          <ac:chgData name="Mahalingam, Mali - ARS" userId="5aabe30f-cbd6-478b-bfc6-4d9b76c11872" providerId="ADAL" clId="{5C32A7D7-E9F0-7348-AA9A-6C8E5EE5DFAA}" dt="2022-10-21T03:21:55.106" v="2" actId="1076"/>
          <ac:picMkLst>
            <pc:docMk/>
            <pc:sldMk cId="2245314376" sldId="256"/>
            <ac:picMk id="6" creationId="{5E2B1188-B7A6-524C-8256-30D56947763C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869351-25E4-8E46-B6EE-6635CFA457C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769F106-4968-7A4C-BA01-73680262CC4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26453C-1B58-DA44-A9A0-64773D3337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2006C-5718-5A4F-ADBB-545F2BAF7132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A86DDE-A97F-5040-AED6-C11ECB56BB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7CA96A-3262-254B-9689-5A32A5ACB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ABE4E-ED09-044C-8C46-B59A81FC2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077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FCA69A-FA8A-A646-BBCB-9646450332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A926C3-69CD-C643-85FA-F856DEDB23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944FFD-ECFE-1C4A-8E1C-17A1668875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2006C-5718-5A4F-ADBB-545F2BAF7132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59656A-1DAF-1B43-B756-6B8960ADA7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0874A5-5B71-6C41-AE4A-98F114351D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ABE4E-ED09-044C-8C46-B59A81FC2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8721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6D8F805-13F7-CB41-87D6-1AA3E0D8AC0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E372BC-D821-9D40-B428-33B0CCA86C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49904D-2849-994C-BD68-A809F4863A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2006C-5718-5A4F-ADBB-545F2BAF7132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AF44DA-D5C8-7342-B607-11A81BA020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5B8603-3495-F849-86FE-E7744A56B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ABE4E-ED09-044C-8C46-B59A81FC2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3878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A5A6EF-506F-3E43-A018-26341AB803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DB0A1D-16C6-304B-97B2-EFC23A3540A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518612-E69B-F043-AB0E-95BDFF8F0C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2006C-5718-5A4F-ADBB-545F2BAF7132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FCDE4F-334D-F54E-9459-ECCA941E5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5DABF3-C721-8048-A9E5-BA1EF748C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ABE4E-ED09-044C-8C46-B59A81FC2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2906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3E8D6A-4236-BE45-917C-6C119B9F69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8CF7D8-D892-4F47-90FB-44F176790F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B129AE-C053-C14C-A53D-691CF4E22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2006C-5718-5A4F-ADBB-545F2BAF7132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C58C0B-0810-7646-9626-5D2A24C6A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B5FB0E-27BB-B740-857D-EDD4845446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ABE4E-ED09-044C-8C46-B59A81FC2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844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6B8532-534E-8A46-B091-A40D27CED6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E42C1C-3033-364B-B8EE-5F3F3BB2523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8967074-8FE2-F745-848E-6FBED67523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3DD6C1-6FBD-3748-98C9-90ED22426E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2006C-5718-5A4F-ADBB-545F2BAF7132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2F4D40-11C9-8249-9425-2FEFA3B706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000B03-13BE-5841-9268-F974C59AB7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ABE4E-ED09-044C-8C46-B59A81FC2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3940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DCBC90-D5A6-1F48-BE60-82DA72797B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366ADF-42FF-1C44-A92E-E1A5520EE7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2F13703-BED9-0D4A-87BC-B32B22742A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BECAA7F-303C-7341-9853-B6417D6124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6331E8A-A9C7-3749-A1FD-CC091F532B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2850D57-8BC3-7E4F-9D4A-A2B75A5AF0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2006C-5718-5A4F-ADBB-545F2BAF7132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F566651-2298-6A48-A2D6-99ADE98B55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A3D9D9-A931-9745-979D-8065C7AB81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ABE4E-ED09-044C-8C46-B59A81FC2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301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1B5AB7-09C9-0F4C-B41E-D654FC6D4D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CCE19ED-EFF1-6146-8EB9-4E53CCBA2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2006C-5718-5A4F-ADBB-545F2BAF7132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41029AB-52ED-CA4A-8A27-C4092B1E8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FDC7220-5F81-E94A-9FF0-52F7CD90D3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ABE4E-ED09-044C-8C46-B59A81FC2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96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41654AD-79D9-0542-ADD0-443447C919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2006C-5718-5A4F-ADBB-545F2BAF7132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6FAD21F-4BA6-3842-8A62-B266990F6E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F66B8C-6790-3B45-9AD7-C2BFA9411C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ABE4E-ED09-044C-8C46-B59A81FC2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114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2C4E77-D319-2A43-91BC-E15B8771E4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D7DE93-39FD-8D45-BA47-356040064FE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C00D07-36AF-174E-9E8B-023B7C7251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BC7D37-9585-BF4B-AB74-A7D6D1609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2006C-5718-5A4F-ADBB-545F2BAF7132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13BAC2-BC8A-A249-ABDC-BC8FB375FF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23D268-B0D8-1B4C-9BFB-EF37F95512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ABE4E-ED09-044C-8C46-B59A81FC2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072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1D8C65-0B46-584D-B265-EF847A6F0E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EB4AD79-ECE5-7D44-B7BE-740AB4B1D05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19D3204-F439-F049-BD60-AE8883A6B5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2EB3F7-601E-4F48-B9F5-8B30CE9287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62006C-5718-5A4F-ADBB-545F2BAF7132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73CDBB-EDAF-E148-A3C4-8C906A72A3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D02D5D-342A-C24D-9E2B-7787E1CB46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ABE4E-ED09-044C-8C46-B59A81FC2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752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78B1406-9E5E-124B-A2C6-E71AAE893C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EEA195-945D-0A4D-8610-15EF8C62E7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466053-CDE3-594F-9FAA-C4504A0163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62006C-5718-5A4F-ADBB-545F2BAF7132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9CD3AC-3CBF-EC44-B61D-4756550A3D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BEA67E-6003-1747-ADC5-42ECC770B5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9ABE4E-ED09-044C-8C46-B59A81FC2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920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5E2B1188-B7A6-524C-8256-30D56947763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863" r="11166"/>
          <a:stretch/>
        </p:blipFill>
        <p:spPr>
          <a:xfrm>
            <a:off x="651641" y="0"/>
            <a:ext cx="8208580" cy="6858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8253975-3FC5-5A4D-9073-4006BFB16C1D}"/>
              </a:ext>
            </a:extLst>
          </p:cNvPr>
          <p:cNvSpPr txBox="1"/>
          <p:nvPr/>
        </p:nvSpPr>
        <p:spPr>
          <a:xfrm>
            <a:off x="7977352" y="5181600"/>
            <a:ext cx="4094711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4. Gene networks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e</a:t>
            </a:r>
            <a:r>
              <a:rPr lang="en-US" sz="1200" spc="-2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etworks</a:t>
            </a:r>
            <a:r>
              <a:rPr lang="en-US" sz="1200" spc="-5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</a:t>
            </a:r>
            <a:r>
              <a:rPr lang="en-US" sz="1200" spc="-3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Gs</a:t>
            </a:r>
            <a:r>
              <a:rPr lang="en-US" sz="1200" spc="-5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volved</a:t>
            </a:r>
            <a:r>
              <a:rPr lang="en-US" sz="1200" spc="-4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der heat</a:t>
            </a:r>
            <a:r>
              <a:rPr lang="en-US" sz="1200" spc="-2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</a:t>
            </a:r>
            <a:r>
              <a:rPr lang="en-US" sz="1200" spc="-4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rought</a:t>
            </a:r>
            <a:r>
              <a:rPr lang="en-US" sz="1200" spc="-2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ress</a:t>
            </a:r>
            <a:r>
              <a:rPr lang="en-US" sz="1200" spc="-3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</a:t>
            </a:r>
            <a:r>
              <a:rPr lang="en-US" sz="1200" spc="-4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</a:t>
            </a:r>
            <a:r>
              <a:rPr lang="en-US" sz="1200" spc="-6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agenta</a:t>
            </a:r>
            <a:r>
              <a:rPr lang="en-US" sz="1200" spc="-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odule.</a:t>
            </a:r>
            <a:r>
              <a:rPr lang="en-US" sz="1200" spc="-3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ze of</a:t>
            </a:r>
            <a:r>
              <a:rPr lang="en-US" sz="1200" spc="-1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</a:t>
            </a:r>
            <a:r>
              <a:rPr lang="en-US" sz="1200" spc="-4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de</a:t>
            </a:r>
            <a:r>
              <a:rPr lang="en-US" sz="1200" spc="-4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</a:t>
            </a:r>
            <a:r>
              <a:rPr lang="en-US" sz="1200" spc="-2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</a:t>
            </a:r>
            <a:r>
              <a:rPr lang="en-US" sz="1200" spc="-2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gree. </a:t>
            </a:r>
          </a:p>
          <a:p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3</a:t>
            </a:r>
            <a:r>
              <a:rPr lang="en-US" sz="1200" spc="-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anscription</a:t>
            </a:r>
            <a:r>
              <a:rPr lang="en-US" sz="1200" spc="-4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actors</a:t>
            </a:r>
            <a:r>
              <a:rPr lang="en-US" sz="1200" spc="-3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re</a:t>
            </a:r>
            <a:r>
              <a:rPr lang="en-US" sz="1200" spc="-4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ed</a:t>
            </a:r>
            <a:r>
              <a:rPr lang="en-US" sz="1200" spc="-4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</a:t>
            </a:r>
            <a:r>
              <a:rPr lang="en-US" sz="1200" spc="-2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urquoise</a:t>
            </a:r>
            <a:r>
              <a:rPr lang="en-US" sz="1200" spc="-4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lor</a:t>
            </a:r>
            <a:r>
              <a:rPr lang="en-US" sz="1200" spc="-3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</a:t>
            </a:r>
            <a:r>
              <a:rPr lang="en-US" sz="1200" spc="-4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l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ther</a:t>
            </a:r>
            <a:r>
              <a:rPr lang="en-US" sz="1200" spc="-3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5</a:t>
            </a:r>
            <a:r>
              <a:rPr lang="en-US" sz="1200" spc="-3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teracting</a:t>
            </a:r>
            <a:r>
              <a:rPr lang="en-US" sz="1200" spc="-1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des</a:t>
            </a:r>
            <a:r>
              <a:rPr lang="en-US" sz="1200" spc="-3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re</a:t>
            </a:r>
            <a:r>
              <a:rPr lang="en-US" sz="1200" spc="-4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ed</a:t>
            </a:r>
            <a:r>
              <a:rPr lang="en-US" sz="1200" spc="-4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</a:t>
            </a:r>
            <a:r>
              <a:rPr lang="en-US" sz="1200" spc="-2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lue</a:t>
            </a:r>
            <a:r>
              <a:rPr lang="en-US" sz="1200" spc="-4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lor.</a:t>
            </a:r>
            <a:r>
              <a:rPr lang="en-US" sz="1200" spc="-3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l</a:t>
            </a:r>
            <a:r>
              <a:rPr lang="en-US" sz="1200" spc="-2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</a:t>
            </a:r>
            <a:r>
              <a:rPr lang="en-US" sz="1200" spc="-4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dges</a:t>
            </a:r>
            <a:r>
              <a:rPr lang="en-US" sz="1200" spc="-3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re</a:t>
            </a:r>
            <a:r>
              <a:rPr lang="en-US" sz="1200" spc="-4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ed</a:t>
            </a:r>
            <a:r>
              <a:rPr lang="en-US" sz="1200" spc="-4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</a:t>
            </a:r>
            <a:r>
              <a:rPr lang="en-US" sz="1200" spc="-1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rksalmon</a:t>
            </a:r>
            <a:r>
              <a:rPr lang="en-US" sz="1200" spc="-45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spc="-1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lor.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53143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58</Words>
  <Application>Microsoft Macintosh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alingam, Mali - ARS</dc:creator>
  <cp:lastModifiedBy>Mahalingam, Mali - ARS</cp:lastModifiedBy>
  <cp:revision>1</cp:revision>
  <dcterms:created xsi:type="dcterms:W3CDTF">2022-09-30T14:21:17Z</dcterms:created>
  <dcterms:modified xsi:type="dcterms:W3CDTF">2022-10-21T03:23:13Z</dcterms:modified>
</cp:coreProperties>
</file>